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824" y="-128"/>
      </p:cViewPr>
      <p:guideLst>
        <p:guide orient="horz" pos="1122"/>
        <p:guide pos="523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9D59F9-412A-7149-97E6-063EB4DA7633}" type="datetimeFigureOut">
              <a:rPr lang="en-US" smtClean="0"/>
              <a:t>4/24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16BCDC-5E6F-1749-8912-E775BB7758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718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885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532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759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213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799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333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304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427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844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168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854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733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>
            <a:off x="4610100" y="338098"/>
            <a:ext cx="1693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pic>
        <p:nvPicPr>
          <p:cNvPr id="18" name="Picture 17" descr="NDRI_Phenotype_Permutations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4900" y="3569732"/>
            <a:ext cx="3200400" cy="320040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610100" y="3944898"/>
            <a:ext cx="1693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857579" y="4094848"/>
            <a:ext cx="1189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NDRI ( n = 18)</a:t>
            </a:r>
            <a:endParaRPr lang="en-US" sz="12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-63500" y="-50800"/>
            <a:ext cx="15711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dditional File 5</a:t>
            </a:r>
            <a:endParaRPr lang="en-US" sz="1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12700" y="333296"/>
            <a:ext cx="1693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12700" y="3944898"/>
            <a:ext cx="1693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pic>
        <p:nvPicPr>
          <p:cNvPr id="5" name="Picture 4" descr="TCGA_BRCA[n]_Permutation_Khat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354"/>
          <a:stretch/>
        </p:blipFill>
        <p:spPr>
          <a:xfrm>
            <a:off x="674155" y="3944898"/>
            <a:ext cx="3657600" cy="2913102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065131" y="139988"/>
            <a:ext cx="26443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TCGA – DNA methylation and age</a:t>
            </a:r>
          </a:p>
          <a:p>
            <a:pPr algn="ctr"/>
            <a:r>
              <a:rPr lang="en-US" sz="1200" b="1" dirty="0" smtClean="0"/>
              <a:t>Associations (n = 97)</a:t>
            </a:r>
            <a:endParaRPr lang="en-US" sz="12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1756752" y="4037231"/>
            <a:ext cx="12064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TCGA( n = 97)</a:t>
            </a:r>
            <a:endParaRPr lang="en-US" sz="1200" b="1" dirty="0"/>
          </a:p>
        </p:txBody>
      </p:sp>
      <p:pic>
        <p:nvPicPr>
          <p:cNvPr id="6" name="Picture 5" descr="RefFree_NDRI_Age_volcano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9200" y="515898"/>
            <a:ext cx="3429000" cy="3429000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5217952" y="148918"/>
            <a:ext cx="25902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NDRI – DNA methylation and age</a:t>
            </a:r>
          </a:p>
          <a:p>
            <a:pPr algn="ctr"/>
            <a:r>
              <a:rPr lang="en-US" sz="1200" b="1" dirty="0" smtClean="0"/>
              <a:t>Associations ( n = 18)</a:t>
            </a:r>
            <a:endParaRPr lang="en-US" sz="1200" b="1" dirty="0"/>
          </a:p>
        </p:txBody>
      </p:sp>
      <p:pic>
        <p:nvPicPr>
          <p:cNvPr id="8" name="Picture 7" descr="RefFree_TCGA_Age_volcano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1955" y="515898"/>
            <a:ext cx="3429000" cy="3429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549132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25096</TotalTime>
  <Words>43</Words>
  <Application>Microsoft Macintosh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Theme</vt:lpstr>
      <vt:lpstr>PowerPoint Presentation</vt:lpstr>
    </vt:vector>
  </TitlesOfParts>
  <Company>Dartmouth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vin Johnson</dc:creator>
  <cp:lastModifiedBy>Kevin Johnson</cp:lastModifiedBy>
  <cp:revision>93</cp:revision>
  <dcterms:created xsi:type="dcterms:W3CDTF">2016-11-21T21:35:34Z</dcterms:created>
  <dcterms:modified xsi:type="dcterms:W3CDTF">2017-04-24T16:07:48Z</dcterms:modified>
</cp:coreProperties>
</file>